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03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32EB284F-7949-FC44-AED4-8C4F679D9722}">
          <p14:sldIdLst>
            <p14:sldId id="303"/>
          </p14:sldIdLst>
        </p14:section>
      </p14:sectionLst>
    </p:ex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7F85FF"/>
    <a:srgbClr val="FC5653"/>
    <a:srgbClr val="FEA0A1"/>
    <a:srgbClr val="FD695A"/>
    <a:srgbClr val="9BADFF"/>
    <a:srgbClr val="495EFF"/>
    <a:srgbClr val="61FF58"/>
    <a:srgbClr val="84FF7D"/>
    <a:srgbClr val="22FF09"/>
    <a:srgbClr val="69CA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067" autoAdjust="0"/>
    <p:restoredTop sz="92475" autoAdjust="0"/>
  </p:normalViewPr>
  <p:slideViewPr>
    <p:cSldViewPr snapToGrid="0" snapToObjects="1">
      <p:cViewPr>
        <p:scale>
          <a:sx n="201" d="100"/>
          <a:sy n="201" d="100"/>
        </p:scale>
        <p:origin x="-760" y="364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Shared:Labs:Rhee:Private:Fan:predict_causual_genes:new_model_tuning:Sorghum_training%20set_ratio%2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Shared:Labs:Rhee:Private:Fan:predict_causual_genes:new_model_tuning:Sorghum_training%20set_ratio%20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Shared:Labs:Rhee:Private:Fan:predict_causual_genes:new_model_tuning:Sorghum_training%20set_ratio%20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Shared:Labs:Rhee:Private:Fan:predict_causual_genes:new_model_tuning:Sorghum_training%20set_ratio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033757101052"/>
          <c:y val="0.133519554890349"/>
          <c:w val="0.719106153849473"/>
          <c:h val="0.55976052580204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4F81BD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B training ratio'!$C$6:$C$15</c:f>
                <c:numCache>
                  <c:formatCode>General</c:formatCode>
                  <c:ptCount val="10"/>
                  <c:pt idx="0">
                    <c:v>0.00124866460134081</c:v>
                  </c:pt>
                  <c:pt idx="1">
                    <c:v>0.00193013495612133</c:v>
                  </c:pt>
                  <c:pt idx="2">
                    <c:v>0.00188724988228575</c:v>
                  </c:pt>
                  <c:pt idx="3">
                    <c:v>0.000966079815513858</c:v>
                  </c:pt>
                  <c:pt idx="4">
                    <c:v>0.000453660456162123</c:v>
                  </c:pt>
                  <c:pt idx="5">
                    <c:v>0.00299459747933671</c:v>
                  </c:pt>
                  <c:pt idx="6">
                    <c:v>0.00163267598519981</c:v>
                  </c:pt>
                  <c:pt idx="7">
                    <c:v>0.0030335847763211</c:v>
                  </c:pt>
                  <c:pt idx="8">
                    <c:v>0.00298589773606006</c:v>
                  </c:pt>
                  <c:pt idx="9">
                    <c:v>0.00152770580707869</c:v>
                  </c:pt>
                </c:numCache>
              </c:numRef>
            </c:plus>
            <c:minus>
              <c:numRef>
                <c:f>'SB training ratio'!$C$6:$C$15</c:f>
                <c:numCache>
                  <c:formatCode>General</c:formatCode>
                  <c:ptCount val="10"/>
                  <c:pt idx="0">
                    <c:v>0.00124866460134081</c:v>
                  </c:pt>
                  <c:pt idx="1">
                    <c:v>0.00193013495612133</c:v>
                  </c:pt>
                  <c:pt idx="2">
                    <c:v>0.00188724988228575</c:v>
                  </c:pt>
                  <c:pt idx="3">
                    <c:v>0.000966079815513858</c:v>
                  </c:pt>
                  <c:pt idx="4">
                    <c:v>0.000453660456162123</c:v>
                  </c:pt>
                  <c:pt idx="5">
                    <c:v>0.00299459747933671</c:v>
                  </c:pt>
                  <c:pt idx="6">
                    <c:v>0.00163267598519981</c:v>
                  </c:pt>
                  <c:pt idx="7">
                    <c:v>0.0030335847763211</c:v>
                  </c:pt>
                  <c:pt idx="8">
                    <c:v>0.00298589773606006</c:v>
                  </c:pt>
                  <c:pt idx="9">
                    <c:v>0.00152770580707869</c:v>
                  </c:pt>
                </c:numCache>
              </c:numRef>
            </c:minus>
          </c:errBars>
          <c:cat>
            <c:strRef>
              <c:f>'SB training ratio'!$A$6:$A$15</c:f>
              <c:strCache>
                <c:ptCount val="10"/>
                <c:pt idx="0">
                  <c:v>10:1</c:v>
                </c:pt>
                <c:pt idx="1">
                  <c:v>5:1</c:v>
                </c:pt>
                <c:pt idx="2">
                  <c:v>2:1</c:v>
                </c:pt>
                <c:pt idx="3">
                  <c:v>1:1</c:v>
                </c:pt>
                <c:pt idx="4">
                  <c:v>1:2</c:v>
                </c:pt>
                <c:pt idx="5">
                  <c:v>1:5</c:v>
                </c:pt>
                <c:pt idx="6">
                  <c:v>1:10</c:v>
                </c:pt>
                <c:pt idx="7">
                  <c:v>1:20</c:v>
                </c:pt>
                <c:pt idx="8">
                  <c:v>1:50</c:v>
                </c:pt>
                <c:pt idx="9">
                  <c:v>1:100</c:v>
                </c:pt>
              </c:strCache>
            </c:strRef>
          </c:cat>
          <c:val>
            <c:numRef>
              <c:f>'SB training ratio'!$B$6:$B$15</c:f>
              <c:numCache>
                <c:formatCode>General</c:formatCode>
                <c:ptCount val="10"/>
                <c:pt idx="0">
                  <c:v>0.672890595254464</c:v>
                </c:pt>
                <c:pt idx="1">
                  <c:v>0.703357984816144</c:v>
                </c:pt>
                <c:pt idx="2">
                  <c:v>0.734065986465718</c:v>
                </c:pt>
                <c:pt idx="3">
                  <c:v>0.751697985631901</c:v>
                </c:pt>
                <c:pt idx="4">
                  <c:v>0.764527859038557</c:v>
                </c:pt>
                <c:pt idx="5">
                  <c:v>0.766903338046511</c:v>
                </c:pt>
                <c:pt idx="6">
                  <c:v>0.75787278007328</c:v>
                </c:pt>
                <c:pt idx="7">
                  <c:v>0.732741530530862</c:v>
                </c:pt>
                <c:pt idx="8">
                  <c:v>0.676510542896524</c:v>
                </c:pt>
                <c:pt idx="9">
                  <c:v>0.63519371853833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2B2-FA45-9B30-75E4BD04FA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1729144"/>
        <c:axId val="-2131607480"/>
      </c:barChart>
      <c:catAx>
        <c:axId val="-21317291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100" b="1" i="0" baseline="0" dirty="0">
                    <a:effectLst/>
                    <a:latin typeface="+mn-lt"/>
                  </a:rPr>
                  <a:t>Ratio of positives and negatives in the training set </a:t>
                </a:r>
                <a:endParaRPr lang="en-US" sz="1100" dirty="0">
                  <a:effectLst/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0.319313063346526"/>
              <c:y val="0.838733195389359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31607480"/>
        <c:crosses val="autoZero"/>
        <c:auto val="1"/>
        <c:lblAlgn val="ctr"/>
        <c:lblOffset val="100"/>
        <c:noMultiLvlLbl val="0"/>
      </c:catAx>
      <c:valAx>
        <c:axId val="-2131607480"/>
        <c:scaling>
          <c:orientation val="minMax"/>
          <c:min val="0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AUC-ROC</a:t>
                </a:r>
              </a:p>
            </c:rich>
          </c:tx>
          <c:layout>
            <c:manualLayout>
              <c:xMode val="edge"/>
              <c:yMode val="edge"/>
              <c:x val="0.000321116059902348"/>
              <c:y val="0.30551000621367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31729144"/>
        <c:crosses val="autoZero"/>
        <c:crossBetween val="between"/>
        <c:majorUnit val="0.05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solidFill>
        <a:srgbClr val="FFFFFF"/>
      </a:solidFill>
    </a:ln>
  </c:spPr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2460368395647"/>
          <c:y val="0.137651821862348"/>
          <c:w val="0.749304389920133"/>
          <c:h val="0.559760525802043"/>
        </c:manualLayout>
      </c:layout>
      <c:barChart>
        <c:barDir val="col"/>
        <c:grouping val="clustered"/>
        <c:varyColors val="0"/>
        <c:ser>
          <c:idx val="1"/>
          <c:order val="0"/>
          <c:spPr>
            <a:solidFill>
              <a:schemeClr val="accent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B training ratio'!$K$6:$K$24</c:f>
                <c:numCache>
                  <c:formatCode>General</c:formatCode>
                  <c:ptCount val="19"/>
                  <c:pt idx="0">
                    <c:v>0.00214095476925472</c:v>
                  </c:pt>
                  <c:pt idx="1">
                    <c:v>0.00138969971157559</c:v>
                  </c:pt>
                  <c:pt idx="2">
                    <c:v>0.00179371082800111</c:v>
                  </c:pt>
                  <c:pt idx="3">
                    <c:v>0.00307614692650992</c:v>
                  </c:pt>
                  <c:pt idx="4">
                    <c:v>0.00133354774270408</c:v>
                  </c:pt>
                  <c:pt idx="5">
                    <c:v>0.0018789661321178</c:v>
                  </c:pt>
                  <c:pt idx="6">
                    <c:v>0.00264063544538315</c:v>
                  </c:pt>
                  <c:pt idx="7">
                    <c:v>0.00193691247850913</c:v>
                  </c:pt>
                  <c:pt idx="8">
                    <c:v>0.00486133382722785</c:v>
                  </c:pt>
                  <c:pt idx="9">
                    <c:v>0.00068558029554711</c:v>
                  </c:pt>
                  <c:pt idx="10">
                    <c:v>0.00201868582965066</c:v>
                  </c:pt>
                  <c:pt idx="11">
                    <c:v>0.00188483700307853</c:v>
                  </c:pt>
                  <c:pt idx="12">
                    <c:v>0.00324244691762952</c:v>
                  </c:pt>
                  <c:pt idx="13">
                    <c:v>0.00217911379413017</c:v>
                  </c:pt>
                </c:numCache>
              </c:numRef>
            </c:plus>
            <c:minus>
              <c:numRef>
                <c:f>'SB training ratio'!$K$6:$K$24</c:f>
                <c:numCache>
                  <c:formatCode>General</c:formatCode>
                  <c:ptCount val="19"/>
                  <c:pt idx="0">
                    <c:v>0.00214095476925472</c:v>
                  </c:pt>
                  <c:pt idx="1">
                    <c:v>0.00138969971157559</c:v>
                  </c:pt>
                  <c:pt idx="2">
                    <c:v>0.00179371082800111</c:v>
                  </c:pt>
                  <c:pt idx="3">
                    <c:v>0.00307614692650992</c:v>
                  </c:pt>
                  <c:pt idx="4">
                    <c:v>0.00133354774270408</c:v>
                  </c:pt>
                  <c:pt idx="5">
                    <c:v>0.0018789661321178</c:v>
                  </c:pt>
                  <c:pt idx="6">
                    <c:v>0.00264063544538315</c:v>
                  </c:pt>
                  <c:pt idx="7">
                    <c:v>0.00193691247850913</c:v>
                  </c:pt>
                  <c:pt idx="8">
                    <c:v>0.00486133382722785</c:v>
                  </c:pt>
                  <c:pt idx="9">
                    <c:v>0.00068558029554711</c:v>
                  </c:pt>
                  <c:pt idx="10">
                    <c:v>0.00201868582965066</c:v>
                  </c:pt>
                  <c:pt idx="11">
                    <c:v>0.00188483700307853</c:v>
                  </c:pt>
                  <c:pt idx="12">
                    <c:v>0.00324244691762952</c:v>
                  </c:pt>
                  <c:pt idx="13">
                    <c:v>0.00217911379413017</c:v>
                  </c:pt>
                </c:numCache>
              </c:numRef>
            </c:minus>
          </c:errBars>
          <c:cat>
            <c:numRef>
              <c:f>'SB training ratio'!$I$8:$I$19</c:f>
              <c:numCache>
                <c:formatCode>General</c:formatCode>
                <c:ptCount val="12"/>
                <c:pt idx="0">
                  <c:v>4.0</c:v>
                </c:pt>
                <c:pt idx="1">
                  <c:v>5.0</c:v>
                </c:pt>
                <c:pt idx="2">
                  <c:v>6.0</c:v>
                </c:pt>
                <c:pt idx="3">
                  <c:v>7.0</c:v>
                </c:pt>
                <c:pt idx="4">
                  <c:v>8.0</c:v>
                </c:pt>
                <c:pt idx="5">
                  <c:v>9.0</c:v>
                </c:pt>
                <c:pt idx="6">
                  <c:v>10.0</c:v>
                </c:pt>
                <c:pt idx="7">
                  <c:v>11.0</c:v>
                </c:pt>
                <c:pt idx="8">
                  <c:v>12.0</c:v>
                </c:pt>
                <c:pt idx="9">
                  <c:v>13.0</c:v>
                </c:pt>
                <c:pt idx="10">
                  <c:v>14.0</c:v>
                </c:pt>
                <c:pt idx="11">
                  <c:v>15.0</c:v>
                </c:pt>
              </c:numCache>
            </c:numRef>
          </c:cat>
          <c:val>
            <c:numRef>
              <c:f>'SB training ratio'!$J$8:$J$19</c:f>
              <c:numCache>
                <c:formatCode>General</c:formatCode>
                <c:ptCount val="12"/>
                <c:pt idx="0">
                  <c:v>0.76708958562403</c:v>
                </c:pt>
                <c:pt idx="1">
                  <c:v>0.767732555614965</c:v>
                </c:pt>
                <c:pt idx="2">
                  <c:v>0.769303269784814</c:v>
                </c:pt>
                <c:pt idx="3">
                  <c:v>0.769723673106924</c:v>
                </c:pt>
                <c:pt idx="4">
                  <c:v>0.766754796111058</c:v>
                </c:pt>
                <c:pt idx="5">
                  <c:v>0.767008443543959</c:v>
                </c:pt>
                <c:pt idx="6">
                  <c:v>0.770125494246024</c:v>
                </c:pt>
                <c:pt idx="7">
                  <c:v>0.770666704301722</c:v>
                </c:pt>
                <c:pt idx="8">
                  <c:v>0.769108295737903</c:v>
                </c:pt>
                <c:pt idx="9">
                  <c:v>0.765891696121141</c:v>
                </c:pt>
                <c:pt idx="10">
                  <c:v>0.769857593316626</c:v>
                </c:pt>
                <c:pt idx="11">
                  <c:v>0.77198429135581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CD5-AC4F-93C4-F4963BF528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42579800"/>
        <c:axId val="-2146136392"/>
      </c:barChart>
      <c:catAx>
        <c:axId val="214257980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100" b="1" i="0" baseline="0" dirty="0">
                    <a:effectLst/>
                    <a:latin typeface="+mn-lt"/>
                  </a:rPr>
                  <a:t>Maximum number of features </a:t>
                </a:r>
                <a:endParaRPr lang="en-US" sz="1100" dirty="0">
                  <a:effectLst/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0.27269629300509"/>
              <c:y val="0.81948880835388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46136392"/>
        <c:crosses val="autoZero"/>
        <c:auto val="1"/>
        <c:lblAlgn val="ctr"/>
        <c:lblOffset val="100"/>
        <c:noMultiLvlLbl val="0"/>
      </c:catAx>
      <c:valAx>
        <c:axId val="-2146136392"/>
        <c:scaling>
          <c:orientation val="minMax"/>
          <c:min val="0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AUC-ROC</a:t>
                </a:r>
              </a:p>
            </c:rich>
          </c:tx>
          <c:layout>
            <c:manualLayout>
              <c:xMode val="edge"/>
              <c:yMode val="edge"/>
              <c:x val="0.000701890092545362"/>
              <c:y val="0.30361163532244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2142579800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8398506300133"/>
          <c:y val="0.137651821862348"/>
          <c:w val="0.687265324912604"/>
          <c:h val="0.55976052580204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4F81BD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B training ratio'!$Q$6:$Q$23</c:f>
                <c:numCache>
                  <c:formatCode>General</c:formatCode>
                  <c:ptCount val="18"/>
                  <c:pt idx="0">
                    <c:v>0.00162403165916695</c:v>
                  </c:pt>
                  <c:pt idx="1">
                    <c:v>0.000549896021030508</c:v>
                  </c:pt>
                  <c:pt idx="2">
                    <c:v>0.00320950086323032</c:v>
                  </c:pt>
                  <c:pt idx="3">
                    <c:v>0.000416545661736218</c:v>
                  </c:pt>
                  <c:pt idx="4">
                    <c:v>0.00244667195479232</c:v>
                  </c:pt>
                  <c:pt idx="5">
                    <c:v>0.00141845126615137</c:v>
                  </c:pt>
                  <c:pt idx="6">
                    <c:v>0.000594988935562268</c:v>
                  </c:pt>
                  <c:pt idx="7">
                    <c:v>0.0016575457354983</c:v>
                  </c:pt>
                  <c:pt idx="8">
                    <c:v>0.000358429115796371</c:v>
                  </c:pt>
                  <c:pt idx="9">
                    <c:v>0.00246951560161918</c:v>
                  </c:pt>
                  <c:pt idx="10">
                    <c:v>0.000490108854465469</c:v>
                  </c:pt>
                  <c:pt idx="11">
                    <c:v>0.00242707402320464</c:v>
                  </c:pt>
                  <c:pt idx="12">
                    <c:v>0.00116101217549377</c:v>
                  </c:pt>
                  <c:pt idx="13">
                    <c:v>0.00258948586961694</c:v>
                  </c:pt>
                </c:numCache>
              </c:numRef>
            </c:plus>
            <c:minus>
              <c:numRef>
                <c:f>'SB training ratio'!$Q$6:$Q$23</c:f>
                <c:numCache>
                  <c:formatCode>General</c:formatCode>
                  <c:ptCount val="18"/>
                  <c:pt idx="0">
                    <c:v>0.00162403165916695</c:v>
                  </c:pt>
                  <c:pt idx="1">
                    <c:v>0.000549896021030508</c:v>
                  </c:pt>
                  <c:pt idx="2">
                    <c:v>0.00320950086323032</c:v>
                  </c:pt>
                  <c:pt idx="3">
                    <c:v>0.000416545661736218</c:v>
                  </c:pt>
                  <c:pt idx="4">
                    <c:v>0.00244667195479232</c:v>
                  </c:pt>
                  <c:pt idx="5">
                    <c:v>0.00141845126615137</c:v>
                  </c:pt>
                  <c:pt idx="6">
                    <c:v>0.000594988935562268</c:v>
                  </c:pt>
                  <c:pt idx="7">
                    <c:v>0.0016575457354983</c:v>
                  </c:pt>
                  <c:pt idx="8">
                    <c:v>0.000358429115796371</c:v>
                  </c:pt>
                  <c:pt idx="9">
                    <c:v>0.00246951560161918</c:v>
                  </c:pt>
                  <c:pt idx="10">
                    <c:v>0.000490108854465469</c:v>
                  </c:pt>
                  <c:pt idx="11">
                    <c:v>0.00242707402320464</c:v>
                  </c:pt>
                  <c:pt idx="12">
                    <c:v>0.00116101217549377</c:v>
                  </c:pt>
                  <c:pt idx="13">
                    <c:v>0.00258948586961694</c:v>
                  </c:pt>
                </c:numCache>
              </c:numRef>
            </c:minus>
          </c:errBars>
          <c:cat>
            <c:numRef>
              <c:f>'SB training ratio'!$O$6:$O$14</c:f>
              <c:numCache>
                <c:formatCode>General</c:formatCode>
                <c:ptCount val="9"/>
                <c:pt idx="0">
                  <c:v>2.0</c:v>
                </c:pt>
                <c:pt idx="1">
                  <c:v>3.0</c:v>
                </c:pt>
                <c:pt idx="2">
                  <c:v>4.0</c:v>
                </c:pt>
                <c:pt idx="3">
                  <c:v>5.0</c:v>
                </c:pt>
                <c:pt idx="4">
                  <c:v>6.0</c:v>
                </c:pt>
                <c:pt idx="5">
                  <c:v>7.0</c:v>
                </c:pt>
                <c:pt idx="6">
                  <c:v>8.0</c:v>
                </c:pt>
                <c:pt idx="7">
                  <c:v>9.0</c:v>
                </c:pt>
                <c:pt idx="8">
                  <c:v>10.0</c:v>
                </c:pt>
              </c:numCache>
            </c:numRef>
          </c:cat>
          <c:val>
            <c:numRef>
              <c:f>'SB training ratio'!$P$6:$P$14</c:f>
              <c:numCache>
                <c:formatCode>General</c:formatCode>
                <c:ptCount val="9"/>
                <c:pt idx="0">
                  <c:v>0.764266844772825</c:v>
                </c:pt>
                <c:pt idx="1">
                  <c:v>0.769078128479887</c:v>
                </c:pt>
                <c:pt idx="2">
                  <c:v>0.772123252406033</c:v>
                </c:pt>
                <c:pt idx="3">
                  <c:v>0.772404683777511</c:v>
                </c:pt>
                <c:pt idx="4">
                  <c:v>0.7763839717407</c:v>
                </c:pt>
                <c:pt idx="5">
                  <c:v>0.775322792302952</c:v>
                </c:pt>
                <c:pt idx="6">
                  <c:v>0.777768660090333</c:v>
                </c:pt>
                <c:pt idx="7">
                  <c:v>0.776572580048791</c:v>
                </c:pt>
                <c:pt idx="8">
                  <c:v>0.77738745787628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17B-E741-A946-25F1256644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76552760"/>
        <c:axId val="-2134030136"/>
      </c:barChart>
      <c:catAx>
        <c:axId val="-207655276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100" b="1" i="0" baseline="0" dirty="0">
                    <a:effectLst/>
                    <a:latin typeface="+mn-lt"/>
                  </a:rPr>
                  <a:t>Minimum number of samples required to split a node </a:t>
                </a:r>
                <a:endParaRPr lang="en-US" sz="1100" dirty="0">
                  <a:effectLst/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0.425015978971468"/>
              <c:y val="0.81583815969284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34030136"/>
        <c:crosses val="autoZero"/>
        <c:auto val="1"/>
        <c:lblAlgn val="ctr"/>
        <c:lblOffset val="100"/>
        <c:noMultiLvlLbl val="0"/>
      </c:catAx>
      <c:valAx>
        <c:axId val="-2134030136"/>
        <c:scaling>
          <c:orientation val="minMax"/>
          <c:min val="0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AUC-ROC</a:t>
                </a:r>
              </a:p>
            </c:rich>
          </c:tx>
          <c:layout>
            <c:manualLayout>
              <c:xMode val="edge"/>
              <c:yMode val="edge"/>
              <c:x val="0.0205882352941176"/>
              <c:y val="0.30774395103446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076552760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9114785221635"/>
          <c:y val="0.137651821862348"/>
          <c:w val="0.73264987954518"/>
          <c:h val="0.55976052580204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4F81BD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B training ratio'!$Z$7:$Z$11</c:f>
                <c:numCache>
                  <c:formatCode>General</c:formatCode>
                  <c:ptCount val="5"/>
                  <c:pt idx="0">
                    <c:v>0.00221789618443719</c:v>
                  </c:pt>
                  <c:pt idx="1">
                    <c:v>0.00246265519258471</c:v>
                  </c:pt>
                  <c:pt idx="2">
                    <c:v>0.000866260436680205</c:v>
                  </c:pt>
                  <c:pt idx="3">
                    <c:v>0.000630461094420533</c:v>
                  </c:pt>
                  <c:pt idx="4">
                    <c:v>0.00198810735475566</c:v>
                  </c:pt>
                </c:numCache>
              </c:numRef>
            </c:plus>
            <c:minus>
              <c:numRef>
                <c:f>'SB training ratio'!$Z$7:$Z$11</c:f>
                <c:numCache>
                  <c:formatCode>General</c:formatCode>
                  <c:ptCount val="5"/>
                  <c:pt idx="0">
                    <c:v>0.00221789618443719</c:v>
                  </c:pt>
                  <c:pt idx="1">
                    <c:v>0.00246265519258471</c:v>
                  </c:pt>
                  <c:pt idx="2">
                    <c:v>0.000866260436680205</c:v>
                  </c:pt>
                  <c:pt idx="3">
                    <c:v>0.000630461094420533</c:v>
                  </c:pt>
                  <c:pt idx="4">
                    <c:v>0.00198810735475566</c:v>
                  </c:pt>
                </c:numCache>
              </c:numRef>
            </c:minus>
          </c:errBars>
          <c:cat>
            <c:numRef>
              <c:f>'SB training ratio'!$X$7:$X$11</c:f>
              <c:numCache>
                <c:formatCode>General</c:formatCode>
                <c:ptCount val="5"/>
                <c:pt idx="0">
                  <c:v>25.0</c:v>
                </c:pt>
                <c:pt idx="1">
                  <c:v>50.0</c:v>
                </c:pt>
                <c:pt idx="2">
                  <c:v>100.0</c:v>
                </c:pt>
                <c:pt idx="3">
                  <c:v>200.0</c:v>
                </c:pt>
                <c:pt idx="4">
                  <c:v>300.0</c:v>
                </c:pt>
              </c:numCache>
            </c:numRef>
          </c:cat>
          <c:val>
            <c:numRef>
              <c:f>'SB training ratio'!$Y$7:$Y$11</c:f>
              <c:numCache>
                <c:formatCode>General</c:formatCode>
                <c:ptCount val="5"/>
                <c:pt idx="0">
                  <c:v>0.755202715105518</c:v>
                </c:pt>
                <c:pt idx="1">
                  <c:v>0.762320508791995</c:v>
                </c:pt>
                <c:pt idx="2">
                  <c:v>0.76976638085051</c:v>
                </c:pt>
                <c:pt idx="3">
                  <c:v>0.768119053175545</c:v>
                </c:pt>
                <c:pt idx="4">
                  <c:v>0.76652699401383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E46-5640-B3E1-B48DE9C654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6144712"/>
        <c:axId val="-2076587976"/>
      </c:barChart>
      <c:catAx>
        <c:axId val="-21461447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100" b="1" i="0" baseline="0" dirty="0">
                    <a:effectLst/>
                    <a:latin typeface="+mn-lt"/>
                  </a:rPr>
                  <a:t>Number of trees </a:t>
                </a:r>
                <a:endParaRPr lang="en-US" sz="1100" dirty="0">
                  <a:effectLst/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0.465071763646276"/>
              <c:y val="0.81754975478369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076587976"/>
        <c:crosses val="autoZero"/>
        <c:auto val="1"/>
        <c:lblAlgn val="ctr"/>
        <c:lblOffset val="100"/>
        <c:noMultiLvlLbl val="0"/>
      </c:catAx>
      <c:valAx>
        <c:axId val="-2076587976"/>
        <c:scaling>
          <c:orientation val="minMax"/>
          <c:min val="0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AUC-ROC</a:t>
                </a:r>
              </a:p>
            </c:rich>
          </c:tx>
          <c:layout>
            <c:manualLayout>
              <c:xMode val="edge"/>
              <c:yMode val="edge"/>
              <c:x val="0.0205882352941176"/>
              <c:y val="0.30774395103446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crossAx val="-2146144712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D5368F-1C20-2147-933B-25F31BF077BE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157C04-4056-9946-94CB-039BCFF2D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0229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E157C04-4056-9946-94CB-039BCFF2D2C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9267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720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563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275167"/>
            <a:ext cx="1543050" cy="585046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275167"/>
            <a:ext cx="4514850" cy="585046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848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880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0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237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030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21"/>
            <a:ext cx="303014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21"/>
            <a:ext cx="303133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985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079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916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9"/>
            <a:ext cx="2256235" cy="154940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342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352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074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879198" y="7975525"/>
            <a:ext cx="52572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Supplemental Figure S3 Parameter tuning for the </a:t>
            </a:r>
            <a:r>
              <a:rPr lang="en-US" sz="1200" i="1" dirty="0"/>
              <a:t>Sorghum bicolor </a:t>
            </a:r>
            <a:r>
              <a:rPr lang="en-US" sz="1200" dirty="0"/>
              <a:t>model based on cross-validation AUC-ROC. Error bars represent standard deviation, N=3. </a:t>
            </a: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79720230"/>
              </p:ext>
            </p:extLst>
          </p:nvPr>
        </p:nvGraphicFramePr>
        <p:xfrm>
          <a:off x="342900" y="1918239"/>
          <a:ext cx="2780926" cy="29064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7115364"/>
              </p:ext>
            </p:extLst>
          </p:nvPr>
        </p:nvGraphicFramePr>
        <p:xfrm>
          <a:off x="3291693" y="1890185"/>
          <a:ext cx="2916864" cy="30148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9766188"/>
              </p:ext>
            </p:extLst>
          </p:nvPr>
        </p:nvGraphicFramePr>
        <p:xfrm>
          <a:off x="284649" y="4642253"/>
          <a:ext cx="2919462" cy="29408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15673209"/>
              </p:ext>
            </p:extLst>
          </p:nvPr>
        </p:nvGraphicFramePr>
        <p:xfrm>
          <a:off x="3204112" y="4642253"/>
          <a:ext cx="3004446" cy="29408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15773178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127</TotalTime>
  <Words>67</Words>
  <Application>Microsoft Macintosh PowerPoint</Application>
  <PresentationFormat>Letter Paper (8.5x11 in)</PresentationFormat>
  <Paragraphs>1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 Lin</dc:creator>
  <cp:lastModifiedBy>Fan Lin</cp:lastModifiedBy>
  <cp:revision>1272</cp:revision>
  <cp:lastPrinted>2020-01-29T19:46:17Z</cp:lastPrinted>
  <dcterms:created xsi:type="dcterms:W3CDTF">2018-04-05T21:34:21Z</dcterms:created>
  <dcterms:modified xsi:type="dcterms:W3CDTF">2020-02-03T04:16:41Z</dcterms:modified>
</cp:coreProperties>
</file>